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80175" cy="9180513"/>
  <p:notesSz cx="6858000" cy="9144000"/>
  <p:defaultTextStyle>
    <a:defPPr>
      <a:defRPr lang="zh-CN"/>
    </a:defPPr>
    <a:lvl1pPr marL="0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1pPr>
    <a:lvl2pPr marL="427071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2pPr>
    <a:lvl3pPr marL="854141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3pPr>
    <a:lvl4pPr marL="1281212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4pPr>
    <a:lvl5pPr marL="1708282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5pPr>
    <a:lvl6pPr marL="2135353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6pPr>
    <a:lvl7pPr marL="2562423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7pPr>
    <a:lvl8pPr marL="2989494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8pPr>
    <a:lvl9pPr marL="3416564" algn="l" defTabSz="854141" rtl="0" eaLnBrk="1" latinLnBrk="0" hangingPunct="1">
      <a:defRPr sz="168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 snapToGrid="0">
      <p:cViewPr varScale="1">
        <p:scale>
          <a:sx n="90" d="100"/>
          <a:sy n="90" d="100"/>
        </p:scale>
        <p:origin x="321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022" y="1502460"/>
            <a:ext cx="4860131" cy="3196179"/>
          </a:xfrm>
        </p:spPr>
        <p:txBody>
          <a:bodyPr anchor="b"/>
          <a:lstStyle>
            <a:lvl1pPr algn="ctr">
              <a:defRPr sz="3128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0022" y="4821895"/>
            <a:ext cx="4860131" cy="2216498"/>
          </a:xfrm>
        </p:spPr>
        <p:txBody>
          <a:bodyPr/>
          <a:lstStyle>
            <a:lvl1pPr marL="0" indent="0" algn="ctr">
              <a:buNone/>
              <a:defRPr sz="1251"/>
            </a:lvl1pPr>
            <a:lvl2pPr marL="238347" indent="0" algn="ctr">
              <a:buNone/>
              <a:defRPr sz="1043"/>
            </a:lvl2pPr>
            <a:lvl3pPr marL="476694" indent="0" algn="ctr">
              <a:buNone/>
              <a:defRPr sz="939"/>
            </a:lvl3pPr>
            <a:lvl4pPr marL="715041" indent="0" algn="ctr">
              <a:buNone/>
              <a:defRPr sz="834"/>
            </a:lvl4pPr>
            <a:lvl5pPr marL="953389" indent="0" algn="ctr">
              <a:buNone/>
              <a:defRPr sz="834"/>
            </a:lvl5pPr>
            <a:lvl6pPr marL="1191736" indent="0" algn="ctr">
              <a:buNone/>
              <a:defRPr sz="834"/>
            </a:lvl6pPr>
            <a:lvl7pPr marL="1430083" indent="0" algn="ctr">
              <a:buNone/>
              <a:defRPr sz="834"/>
            </a:lvl7pPr>
            <a:lvl8pPr marL="1668430" indent="0" algn="ctr">
              <a:buNone/>
              <a:defRPr sz="834"/>
            </a:lvl8pPr>
            <a:lvl9pPr marL="1906777" indent="0" algn="ctr">
              <a:buNone/>
              <a:defRPr sz="834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77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76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37375" y="488778"/>
            <a:ext cx="1397287" cy="778006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45512" y="488778"/>
            <a:ext cx="4110861" cy="7780060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048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2349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2138" y="2288756"/>
            <a:ext cx="5589151" cy="3818838"/>
          </a:xfrm>
        </p:spPr>
        <p:txBody>
          <a:bodyPr anchor="b"/>
          <a:lstStyle>
            <a:lvl1pPr>
              <a:defRPr sz="3128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2138" y="6143721"/>
            <a:ext cx="5589151" cy="2008237"/>
          </a:xfrm>
        </p:spPr>
        <p:txBody>
          <a:bodyPr/>
          <a:lstStyle>
            <a:lvl1pPr marL="0" indent="0">
              <a:buNone/>
              <a:defRPr sz="1251">
                <a:solidFill>
                  <a:schemeClr val="tx1">
                    <a:tint val="75000"/>
                  </a:schemeClr>
                </a:solidFill>
              </a:defRPr>
            </a:lvl1pPr>
            <a:lvl2pPr marL="238347" indent="0">
              <a:buNone/>
              <a:defRPr sz="1043">
                <a:solidFill>
                  <a:schemeClr val="tx1">
                    <a:tint val="75000"/>
                  </a:schemeClr>
                </a:solidFill>
              </a:defRPr>
            </a:lvl2pPr>
            <a:lvl3pPr marL="476694" indent="0">
              <a:buNone/>
              <a:defRPr sz="939">
                <a:solidFill>
                  <a:schemeClr val="tx1">
                    <a:tint val="75000"/>
                  </a:schemeClr>
                </a:solidFill>
              </a:defRPr>
            </a:lvl3pPr>
            <a:lvl4pPr marL="715041" indent="0">
              <a:buNone/>
              <a:defRPr sz="834">
                <a:solidFill>
                  <a:schemeClr val="tx1">
                    <a:tint val="75000"/>
                  </a:schemeClr>
                </a:solidFill>
              </a:defRPr>
            </a:lvl4pPr>
            <a:lvl5pPr marL="953389" indent="0">
              <a:buNone/>
              <a:defRPr sz="834">
                <a:solidFill>
                  <a:schemeClr val="tx1">
                    <a:tint val="75000"/>
                  </a:schemeClr>
                </a:solidFill>
              </a:defRPr>
            </a:lvl5pPr>
            <a:lvl6pPr marL="1191736" indent="0">
              <a:buNone/>
              <a:defRPr sz="834">
                <a:solidFill>
                  <a:schemeClr val="tx1">
                    <a:tint val="75000"/>
                  </a:schemeClr>
                </a:solidFill>
              </a:defRPr>
            </a:lvl6pPr>
            <a:lvl7pPr marL="1430083" indent="0">
              <a:buNone/>
              <a:defRPr sz="834">
                <a:solidFill>
                  <a:schemeClr val="tx1">
                    <a:tint val="75000"/>
                  </a:schemeClr>
                </a:solidFill>
              </a:defRPr>
            </a:lvl7pPr>
            <a:lvl8pPr marL="1668430" indent="0">
              <a:buNone/>
              <a:defRPr sz="834">
                <a:solidFill>
                  <a:schemeClr val="tx1">
                    <a:tint val="75000"/>
                  </a:schemeClr>
                </a:solidFill>
              </a:defRPr>
            </a:lvl8pPr>
            <a:lvl9pPr marL="1906777" indent="0">
              <a:buNone/>
              <a:defRPr sz="8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894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45513" y="2443887"/>
            <a:ext cx="2754074" cy="58249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80589" y="2443887"/>
            <a:ext cx="2754074" cy="58249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4405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57" y="488779"/>
            <a:ext cx="5589151" cy="1774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6357" y="2250502"/>
            <a:ext cx="2741417" cy="1102936"/>
          </a:xfrm>
        </p:spPr>
        <p:txBody>
          <a:bodyPr anchor="b"/>
          <a:lstStyle>
            <a:lvl1pPr marL="0" indent="0">
              <a:buNone/>
              <a:defRPr sz="1251" b="1"/>
            </a:lvl1pPr>
            <a:lvl2pPr marL="238347" indent="0">
              <a:buNone/>
              <a:defRPr sz="1043" b="1"/>
            </a:lvl2pPr>
            <a:lvl3pPr marL="476694" indent="0">
              <a:buNone/>
              <a:defRPr sz="939" b="1"/>
            </a:lvl3pPr>
            <a:lvl4pPr marL="715041" indent="0">
              <a:buNone/>
              <a:defRPr sz="834" b="1"/>
            </a:lvl4pPr>
            <a:lvl5pPr marL="953389" indent="0">
              <a:buNone/>
              <a:defRPr sz="834" b="1"/>
            </a:lvl5pPr>
            <a:lvl6pPr marL="1191736" indent="0">
              <a:buNone/>
              <a:defRPr sz="834" b="1"/>
            </a:lvl6pPr>
            <a:lvl7pPr marL="1430083" indent="0">
              <a:buNone/>
              <a:defRPr sz="834" b="1"/>
            </a:lvl7pPr>
            <a:lvl8pPr marL="1668430" indent="0">
              <a:buNone/>
              <a:defRPr sz="834" b="1"/>
            </a:lvl8pPr>
            <a:lvl9pPr marL="1906777" indent="0">
              <a:buNone/>
              <a:defRPr sz="834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6357" y="3353438"/>
            <a:ext cx="2741417" cy="49324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80590" y="2250502"/>
            <a:ext cx="2754918" cy="1102936"/>
          </a:xfrm>
        </p:spPr>
        <p:txBody>
          <a:bodyPr anchor="b"/>
          <a:lstStyle>
            <a:lvl1pPr marL="0" indent="0">
              <a:buNone/>
              <a:defRPr sz="1251" b="1"/>
            </a:lvl1pPr>
            <a:lvl2pPr marL="238347" indent="0">
              <a:buNone/>
              <a:defRPr sz="1043" b="1"/>
            </a:lvl2pPr>
            <a:lvl3pPr marL="476694" indent="0">
              <a:buNone/>
              <a:defRPr sz="939" b="1"/>
            </a:lvl3pPr>
            <a:lvl4pPr marL="715041" indent="0">
              <a:buNone/>
              <a:defRPr sz="834" b="1"/>
            </a:lvl4pPr>
            <a:lvl5pPr marL="953389" indent="0">
              <a:buNone/>
              <a:defRPr sz="834" b="1"/>
            </a:lvl5pPr>
            <a:lvl6pPr marL="1191736" indent="0">
              <a:buNone/>
              <a:defRPr sz="834" b="1"/>
            </a:lvl6pPr>
            <a:lvl7pPr marL="1430083" indent="0">
              <a:buNone/>
              <a:defRPr sz="834" b="1"/>
            </a:lvl7pPr>
            <a:lvl8pPr marL="1668430" indent="0">
              <a:buNone/>
              <a:defRPr sz="834" b="1"/>
            </a:lvl8pPr>
            <a:lvl9pPr marL="1906777" indent="0">
              <a:buNone/>
              <a:defRPr sz="834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80590" y="3353438"/>
            <a:ext cx="2754918" cy="49324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0898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1080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5041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56" y="612034"/>
            <a:ext cx="2090026" cy="2142120"/>
          </a:xfrm>
        </p:spPr>
        <p:txBody>
          <a:bodyPr anchor="b"/>
          <a:lstStyle>
            <a:lvl1pPr>
              <a:defRPr sz="1668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754919" y="1321827"/>
            <a:ext cx="3280589" cy="6524115"/>
          </a:xfrm>
        </p:spPr>
        <p:txBody>
          <a:bodyPr/>
          <a:lstStyle>
            <a:lvl1pPr>
              <a:defRPr sz="1668"/>
            </a:lvl1pPr>
            <a:lvl2pPr>
              <a:defRPr sz="1460"/>
            </a:lvl2pPr>
            <a:lvl3pPr>
              <a:defRPr sz="1251"/>
            </a:lvl3pPr>
            <a:lvl4pPr>
              <a:defRPr sz="1043"/>
            </a:lvl4pPr>
            <a:lvl5pPr>
              <a:defRPr sz="1043"/>
            </a:lvl5pPr>
            <a:lvl6pPr>
              <a:defRPr sz="1043"/>
            </a:lvl6pPr>
            <a:lvl7pPr>
              <a:defRPr sz="1043"/>
            </a:lvl7pPr>
            <a:lvl8pPr>
              <a:defRPr sz="1043"/>
            </a:lvl8pPr>
            <a:lvl9pPr>
              <a:defRPr sz="1043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56" y="2754154"/>
            <a:ext cx="2090026" cy="5102411"/>
          </a:xfrm>
        </p:spPr>
        <p:txBody>
          <a:bodyPr/>
          <a:lstStyle>
            <a:lvl1pPr marL="0" indent="0">
              <a:buNone/>
              <a:defRPr sz="834"/>
            </a:lvl1pPr>
            <a:lvl2pPr marL="238347" indent="0">
              <a:buNone/>
              <a:defRPr sz="730"/>
            </a:lvl2pPr>
            <a:lvl3pPr marL="476694" indent="0">
              <a:buNone/>
              <a:defRPr sz="626"/>
            </a:lvl3pPr>
            <a:lvl4pPr marL="715041" indent="0">
              <a:buNone/>
              <a:defRPr sz="522"/>
            </a:lvl4pPr>
            <a:lvl5pPr marL="953389" indent="0">
              <a:buNone/>
              <a:defRPr sz="522"/>
            </a:lvl5pPr>
            <a:lvl6pPr marL="1191736" indent="0">
              <a:buNone/>
              <a:defRPr sz="522"/>
            </a:lvl6pPr>
            <a:lvl7pPr marL="1430083" indent="0">
              <a:buNone/>
              <a:defRPr sz="522"/>
            </a:lvl7pPr>
            <a:lvl8pPr marL="1668430" indent="0">
              <a:buNone/>
              <a:defRPr sz="522"/>
            </a:lvl8pPr>
            <a:lvl9pPr marL="1906777" indent="0">
              <a:buNone/>
              <a:defRPr sz="522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8288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56" y="612034"/>
            <a:ext cx="2090026" cy="2142120"/>
          </a:xfrm>
        </p:spPr>
        <p:txBody>
          <a:bodyPr anchor="b"/>
          <a:lstStyle>
            <a:lvl1pPr>
              <a:defRPr sz="1668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754919" y="1321827"/>
            <a:ext cx="3280589" cy="6524115"/>
          </a:xfrm>
        </p:spPr>
        <p:txBody>
          <a:bodyPr/>
          <a:lstStyle>
            <a:lvl1pPr marL="0" indent="0">
              <a:buNone/>
              <a:defRPr sz="1668"/>
            </a:lvl1pPr>
            <a:lvl2pPr marL="238347" indent="0">
              <a:buNone/>
              <a:defRPr sz="1460"/>
            </a:lvl2pPr>
            <a:lvl3pPr marL="476694" indent="0">
              <a:buNone/>
              <a:defRPr sz="1251"/>
            </a:lvl3pPr>
            <a:lvl4pPr marL="715041" indent="0">
              <a:buNone/>
              <a:defRPr sz="1043"/>
            </a:lvl4pPr>
            <a:lvl5pPr marL="953389" indent="0">
              <a:buNone/>
              <a:defRPr sz="1043"/>
            </a:lvl5pPr>
            <a:lvl6pPr marL="1191736" indent="0">
              <a:buNone/>
              <a:defRPr sz="1043"/>
            </a:lvl6pPr>
            <a:lvl7pPr marL="1430083" indent="0">
              <a:buNone/>
              <a:defRPr sz="1043"/>
            </a:lvl7pPr>
            <a:lvl8pPr marL="1668430" indent="0">
              <a:buNone/>
              <a:defRPr sz="1043"/>
            </a:lvl8pPr>
            <a:lvl9pPr marL="1906777" indent="0">
              <a:buNone/>
              <a:defRPr sz="104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56" y="2754154"/>
            <a:ext cx="2090026" cy="5102411"/>
          </a:xfrm>
        </p:spPr>
        <p:txBody>
          <a:bodyPr/>
          <a:lstStyle>
            <a:lvl1pPr marL="0" indent="0">
              <a:buNone/>
              <a:defRPr sz="834"/>
            </a:lvl1pPr>
            <a:lvl2pPr marL="238347" indent="0">
              <a:buNone/>
              <a:defRPr sz="730"/>
            </a:lvl2pPr>
            <a:lvl3pPr marL="476694" indent="0">
              <a:buNone/>
              <a:defRPr sz="626"/>
            </a:lvl3pPr>
            <a:lvl4pPr marL="715041" indent="0">
              <a:buNone/>
              <a:defRPr sz="522"/>
            </a:lvl4pPr>
            <a:lvl5pPr marL="953389" indent="0">
              <a:buNone/>
              <a:defRPr sz="522"/>
            </a:lvl5pPr>
            <a:lvl6pPr marL="1191736" indent="0">
              <a:buNone/>
              <a:defRPr sz="522"/>
            </a:lvl6pPr>
            <a:lvl7pPr marL="1430083" indent="0">
              <a:buNone/>
              <a:defRPr sz="522"/>
            </a:lvl7pPr>
            <a:lvl8pPr marL="1668430" indent="0">
              <a:buNone/>
              <a:defRPr sz="522"/>
            </a:lvl8pPr>
            <a:lvl9pPr marL="1906777" indent="0">
              <a:buNone/>
              <a:defRPr sz="522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1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45513" y="488779"/>
            <a:ext cx="5589151" cy="1774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5513" y="2443887"/>
            <a:ext cx="5589151" cy="58249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45513" y="8508978"/>
            <a:ext cx="1458039" cy="4887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0A330-2171-4917-BDBC-DFBCE45623FE}" type="datetimeFigureOut">
              <a:rPr lang="zh-CN" altLang="en-US" smtClean="0"/>
              <a:t>2024/4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146559" y="8508978"/>
            <a:ext cx="2187059" cy="4887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576624" y="8508978"/>
            <a:ext cx="1458039" cy="4887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6B529-0D8B-4C6F-BAEE-ADDECD8674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6172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76694" rtl="0" eaLnBrk="1" latinLnBrk="0" hangingPunct="1">
        <a:lnSpc>
          <a:spcPct val="90000"/>
        </a:lnSpc>
        <a:spcBef>
          <a:spcPct val="0"/>
        </a:spcBef>
        <a:buNone/>
        <a:defRPr sz="22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9174" indent="-119174" algn="l" defTabSz="476694" rtl="0" eaLnBrk="1" latinLnBrk="0" hangingPunct="1">
        <a:lnSpc>
          <a:spcPct val="90000"/>
        </a:lnSpc>
        <a:spcBef>
          <a:spcPts val="522"/>
        </a:spcBef>
        <a:buFont typeface="Arial" panose="020B0604020202020204" pitchFamily="34" charset="0"/>
        <a:buChar char="•"/>
        <a:defRPr sz="1460" kern="1200">
          <a:solidFill>
            <a:schemeClr val="tx1"/>
          </a:solidFill>
          <a:latin typeface="+mn-lt"/>
          <a:ea typeface="+mn-ea"/>
          <a:cs typeface="+mn-cs"/>
        </a:defRPr>
      </a:lvl1pPr>
      <a:lvl2pPr marL="357521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251" kern="1200">
          <a:solidFill>
            <a:schemeClr val="tx1"/>
          </a:solidFill>
          <a:latin typeface="+mn-lt"/>
          <a:ea typeface="+mn-ea"/>
          <a:cs typeface="+mn-cs"/>
        </a:defRPr>
      </a:lvl2pPr>
      <a:lvl3pPr marL="595868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043" kern="1200">
          <a:solidFill>
            <a:schemeClr val="tx1"/>
          </a:solidFill>
          <a:latin typeface="+mn-lt"/>
          <a:ea typeface="+mn-ea"/>
          <a:cs typeface="+mn-cs"/>
        </a:defRPr>
      </a:lvl3pPr>
      <a:lvl4pPr marL="834215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9" kern="1200">
          <a:solidFill>
            <a:schemeClr val="tx1"/>
          </a:solidFill>
          <a:latin typeface="+mn-lt"/>
          <a:ea typeface="+mn-ea"/>
          <a:cs typeface="+mn-cs"/>
        </a:defRPr>
      </a:lvl4pPr>
      <a:lvl5pPr marL="1072562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9" kern="1200">
          <a:solidFill>
            <a:schemeClr val="tx1"/>
          </a:solidFill>
          <a:latin typeface="+mn-lt"/>
          <a:ea typeface="+mn-ea"/>
          <a:cs typeface="+mn-cs"/>
        </a:defRPr>
      </a:lvl5pPr>
      <a:lvl6pPr marL="1310909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9" kern="1200">
          <a:solidFill>
            <a:schemeClr val="tx1"/>
          </a:solidFill>
          <a:latin typeface="+mn-lt"/>
          <a:ea typeface="+mn-ea"/>
          <a:cs typeface="+mn-cs"/>
        </a:defRPr>
      </a:lvl6pPr>
      <a:lvl7pPr marL="1549256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9" kern="1200">
          <a:solidFill>
            <a:schemeClr val="tx1"/>
          </a:solidFill>
          <a:latin typeface="+mn-lt"/>
          <a:ea typeface="+mn-ea"/>
          <a:cs typeface="+mn-cs"/>
        </a:defRPr>
      </a:lvl7pPr>
      <a:lvl8pPr marL="1787603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9" kern="1200">
          <a:solidFill>
            <a:schemeClr val="tx1"/>
          </a:solidFill>
          <a:latin typeface="+mn-lt"/>
          <a:ea typeface="+mn-ea"/>
          <a:cs typeface="+mn-cs"/>
        </a:defRPr>
      </a:lvl8pPr>
      <a:lvl9pPr marL="2025951" indent="-119174" algn="l" defTabSz="47669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1pPr>
      <a:lvl2pPr marL="238347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2pPr>
      <a:lvl3pPr marL="476694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3pPr>
      <a:lvl4pPr marL="715041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4pPr>
      <a:lvl5pPr marL="953389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5pPr>
      <a:lvl6pPr marL="1191736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6pPr>
      <a:lvl7pPr marL="1430083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7pPr>
      <a:lvl8pPr marL="1668430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8pPr>
      <a:lvl9pPr marL="1906777" algn="l" defTabSz="476694" rtl="0" eaLnBrk="1" latinLnBrk="0" hangingPunct="1">
        <a:defRPr sz="9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958" y="1009587"/>
            <a:ext cx="1706343" cy="132888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958" y="2558984"/>
            <a:ext cx="1706343" cy="88123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324" y="1009587"/>
            <a:ext cx="1499096" cy="136481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324" y="2558984"/>
            <a:ext cx="1615685" cy="872042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1463757" y="1336236"/>
            <a:ext cx="914400" cy="584616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1468052" y="2847352"/>
            <a:ext cx="914400" cy="31441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4172599" y="1379168"/>
            <a:ext cx="914400" cy="584616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4176894" y="2864528"/>
            <a:ext cx="914400" cy="314410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50761" y="1468191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10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29303" y="286983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462258" y="1466051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10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389285" y="286769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 rot="18901930">
            <a:off x="1156951" y="3500898"/>
            <a:ext cx="6202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8901930">
            <a:off x="1168173" y="3621103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-PEG10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8901930">
            <a:off x="1096183" y="3792820"/>
            <a:ext cx="14157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-PEG10-2ORF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rot="18901930">
            <a:off x="4024989" y="3470852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si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 rot="18901930">
            <a:off x="3952890" y="3597496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10si-1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 rot="18901930">
            <a:off x="4253392" y="3627551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G10si-2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633469" y="719071"/>
            <a:ext cx="6575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VEC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329435" y="723366"/>
            <a:ext cx="6575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VEC</a:t>
            </a:r>
            <a:endParaRPr lang="zh-CN" altLang="en-US" sz="12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693824" y="122564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2723877" y="150038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cxnSp>
        <p:nvCxnSpPr>
          <p:cNvPr id="28" name="直接连接符 27"/>
          <p:cNvCxnSpPr/>
          <p:nvPr/>
        </p:nvCxnSpPr>
        <p:spPr>
          <a:xfrm>
            <a:off x="2680946" y="1620584"/>
            <a:ext cx="12664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5441303" y="124281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5471356" y="1536877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cxnSp>
        <p:nvCxnSpPr>
          <p:cNvPr id="31" name="直接连接符 30"/>
          <p:cNvCxnSpPr/>
          <p:nvPr/>
        </p:nvCxnSpPr>
        <p:spPr>
          <a:xfrm>
            <a:off x="5428425" y="1657078"/>
            <a:ext cx="12664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2698122" y="2698116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2728175" y="294710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34" name="直接连接符 33"/>
          <p:cNvCxnSpPr/>
          <p:nvPr/>
        </p:nvCxnSpPr>
        <p:spPr>
          <a:xfrm>
            <a:off x="2685244" y="3067304"/>
            <a:ext cx="12664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5535756" y="2676651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5565809" y="2951394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5522878" y="3071595"/>
            <a:ext cx="12664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145962" y="319830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32b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241167" y="324128"/>
            <a:ext cx="7248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32d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3541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6</Words>
  <Application>Microsoft Macintosh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</dc:creator>
  <cp:lastModifiedBy>WAN JIN</cp:lastModifiedBy>
  <cp:revision>5</cp:revision>
  <dcterms:created xsi:type="dcterms:W3CDTF">2024-04-02T05:45:59Z</dcterms:created>
  <dcterms:modified xsi:type="dcterms:W3CDTF">2024-04-09T03:16:51Z</dcterms:modified>
</cp:coreProperties>
</file>